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2" d="100"/>
          <a:sy n="52" d="100"/>
        </p:scale>
        <p:origin x="159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375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393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713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595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739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616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500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143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836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164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30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E48BD-13A9-4442-A029-E28DF3E185AA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6F62E-8911-4353-8D34-DCEF407B914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669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9107559"/>
              </p:ext>
            </p:extLst>
          </p:nvPr>
        </p:nvGraphicFramePr>
        <p:xfrm>
          <a:off x="839755" y="298580"/>
          <a:ext cx="5691674" cy="40067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7" r:id="rId3" imgW="6128790" imgH="4314645" progId="Prism7.Document">
                  <p:embed/>
                </p:oleObj>
              </mc:Choice>
              <mc:Fallback>
                <p:oleObj name="Prism 7" r:id="rId3" imgW="6128790" imgH="431464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9755" y="298580"/>
                        <a:ext cx="5691674" cy="40067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ttangolo 4"/>
          <p:cNvSpPr/>
          <p:nvPr/>
        </p:nvSpPr>
        <p:spPr>
          <a:xfrm>
            <a:off x="655681" y="4777272"/>
            <a:ext cx="520394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BsAg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uantification with and without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nicamycin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h7 cells were transfected with a plasmid encod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mutated strep-tagge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BsA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fter 6h, the glycosylation inhibit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nicamyc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added at the concentration of 1μg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L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48h, strep-tagge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BsA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eased in the supernatants of cells in absenc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nicamyc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rey bars) and in presence of this N-glycosylation inhibitor (black bars) were quantified by commercial ELISA using antibodies targeting the major hydrophilic reg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BsA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32598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84</Words>
  <Application>Microsoft Office PowerPoint</Application>
  <PresentationFormat>A4 (21x29,7 cm)</PresentationFormat>
  <Paragraphs>2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GraphPad Prism 7 Project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mina</dc:creator>
  <cp:lastModifiedBy>Romina</cp:lastModifiedBy>
  <cp:revision>4</cp:revision>
  <dcterms:created xsi:type="dcterms:W3CDTF">2020-02-17T14:02:29Z</dcterms:created>
  <dcterms:modified xsi:type="dcterms:W3CDTF">2020-02-17T14:18:14Z</dcterms:modified>
</cp:coreProperties>
</file>